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6858000" cy="9144000" type="screen4x3"/>
  <p:notesSz cx="6797675" cy="987425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11" autoAdjust="0"/>
    <p:restoredTop sz="94656" autoAdjust="0"/>
  </p:normalViewPr>
  <p:slideViewPr>
    <p:cSldViewPr>
      <p:cViewPr varScale="1">
        <p:scale>
          <a:sx n="44" d="100"/>
          <a:sy n="44" d="100"/>
        </p:scale>
        <p:origin x="2388" y="4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nnele Tuominen" userId="19b6fe73-40b8-4e3a-9115-dd7fe7dada74" providerId="ADAL" clId="{8683E76B-6F4B-4665-9BF6-285930567DDC}"/>
    <pc:docChg chg="modSld">
      <pc:chgData name="Hannele Tuominen" userId="19b6fe73-40b8-4e3a-9115-dd7fe7dada74" providerId="ADAL" clId="{8683E76B-6F4B-4665-9BF6-285930567DDC}" dt="2017-11-30T13:23:31.157" v="10" actId="20577"/>
      <pc:docMkLst>
        <pc:docMk/>
      </pc:docMkLst>
      <pc:sldChg chg="modSp">
        <pc:chgData name="Hannele Tuominen" userId="19b6fe73-40b8-4e3a-9115-dd7fe7dada74" providerId="ADAL" clId="{8683E76B-6F4B-4665-9BF6-285930567DDC}" dt="2017-11-30T13:23:31.157" v="10" actId="20577"/>
        <pc:sldMkLst>
          <pc:docMk/>
          <pc:sldMk cId="752779917" sldId="270"/>
        </pc:sldMkLst>
        <pc:spChg chg="mod">
          <ac:chgData name="Hannele Tuominen" userId="19b6fe73-40b8-4e3a-9115-dd7fe7dada74" providerId="ADAL" clId="{8683E76B-6F4B-4665-9BF6-285930567DDC}" dt="2017-11-30T13:23:31.157" v="10" actId="20577"/>
          <ac:spMkLst>
            <pc:docMk/>
            <pc:sldMk cId="752779917" sldId="270"/>
            <ac:spMk id="40" creationId="{00000000-0000-0000-0000-000000000000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>
                <a:solidFill>
                  <a:schemeClr val="tx1"/>
                </a:solidFill>
              </a:rPr>
              <a:t>DGDG (36:6) 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KW$9:$AKW$12</c:f>
                <c:numCache>
                  <c:formatCode>General</c:formatCode>
                  <c:ptCount val="4"/>
                  <c:pt idx="0">
                    <c:v>1817.074558839277</c:v>
                  </c:pt>
                  <c:pt idx="1">
                    <c:v>4094.079098731077</c:v>
                  </c:pt>
                  <c:pt idx="2">
                    <c:v>2305.3523158077155</c:v>
                  </c:pt>
                  <c:pt idx="3">
                    <c:v>3408.1226063626295</c:v>
                  </c:pt>
                </c:numCache>
              </c:numRef>
            </c:plus>
            <c:minus>
              <c:numRef>
                <c:f>Sheet1!$AKW$9:$AKW$12</c:f>
                <c:numCache>
                  <c:formatCode>General</c:formatCode>
                  <c:ptCount val="4"/>
                  <c:pt idx="0">
                    <c:v>1817.074558839277</c:v>
                  </c:pt>
                  <c:pt idx="1">
                    <c:v>4094.079098731077</c:v>
                  </c:pt>
                  <c:pt idx="2">
                    <c:v>2305.3523158077155</c:v>
                  </c:pt>
                  <c:pt idx="3">
                    <c:v>3408.12260636262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4:$A$7</c:f>
              <c:strCache>
                <c:ptCount val="4"/>
                <c:pt idx="0">
                  <c:v>T89</c:v>
                </c:pt>
                <c:pt idx="1">
                  <c:v>Line 1</c:v>
                </c:pt>
                <c:pt idx="2">
                  <c:v>Line 2</c:v>
                </c:pt>
                <c:pt idx="3">
                  <c:v>Line 3</c:v>
                </c:pt>
              </c:strCache>
            </c:strRef>
          </c:cat>
          <c:val>
            <c:numRef>
              <c:f>Sheet1!$AKW$4:$AKW$7</c:f>
              <c:numCache>
                <c:formatCode>General</c:formatCode>
                <c:ptCount val="4"/>
                <c:pt idx="0" formatCode="0.00E+00">
                  <c:v>3748.5714285714284</c:v>
                </c:pt>
                <c:pt idx="1">
                  <c:v>6123.5</c:v>
                </c:pt>
                <c:pt idx="2">
                  <c:v>9403.6</c:v>
                </c:pt>
                <c:pt idx="3">
                  <c:v>6984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595-472D-B8DE-4041A653AB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9652552"/>
        <c:axId val="339652944"/>
      </c:barChart>
      <c:catAx>
        <c:axId val="339652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39652944"/>
        <c:crosses val="autoZero"/>
        <c:auto val="1"/>
        <c:lblAlgn val="ctr"/>
        <c:lblOffset val="100"/>
        <c:noMultiLvlLbl val="0"/>
      </c:catAx>
      <c:valAx>
        <c:axId val="339652944"/>
        <c:scaling>
          <c:orientation val="minMax"/>
        </c:scaling>
        <c:delete val="0"/>
        <c:axPos val="l"/>
        <c:numFmt formatCode="0.00E+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396525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sz="1400" b="0" i="0" baseline="0" dirty="0">
                <a:solidFill>
                  <a:schemeClr val="tx1"/>
                </a:solidFill>
                <a:effectLst/>
              </a:rPr>
              <a:t>MGDG (36:3)</a:t>
            </a:r>
            <a:endParaRPr lang="sv-SE" sz="1400" dirty="0">
              <a:solidFill>
                <a:schemeClr val="tx1"/>
              </a:solidFill>
              <a:effectLst/>
            </a:endParaRP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LL$9:$ALL$12</c:f>
                <c:numCache>
                  <c:formatCode>General</c:formatCode>
                  <c:ptCount val="4"/>
                  <c:pt idx="0">
                    <c:v>27728.127216824094</c:v>
                  </c:pt>
                  <c:pt idx="1">
                    <c:v>55802.642813012601</c:v>
                  </c:pt>
                  <c:pt idx="2">
                    <c:v>36388.996177416091</c:v>
                  </c:pt>
                  <c:pt idx="3">
                    <c:v>54751.72210716299</c:v>
                  </c:pt>
                </c:numCache>
              </c:numRef>
            </c:plus>
            <c:minus>
              <c:numRef>
                <c:f>Sheet1!$ALL$9:$ALL$12</c:f>
                <c:numCache>
                  <c:formatCode>General</c:formatCode>
                  <c:ptCount val="4"/>
                  <c:pt idx="0">
                    <c:v>27728.127216824094</c:v>
                  </c:pt>
                  <c:pt idx="1">
                    <c:v>55802.642813012601</c:v>
                  </c:pt>
                  <c:pt idx="2">
                    <c:v>36388.996177416091</c:v>
                  </c:pt>
                  <c:pt idx="3">
                    <c:v>54751.722107162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4:$A$7</c:f>
              <c:strCache>
                <c:ptCount val="4"/>
                <c:pt idx="0">
                  <c:v>T89</c:v>
                </c:pt>
                <c:pt idx="1">
                  <c:v>Line 1</c:v>
                </c:pt>
                <c:pt idx="2">
                  <c:v>Line 2</c:v>
                </c:pt>
                <c:pt idx="3">
                  <c:v>Line 3</c:v>
                </c:pt>
              </c:strCache>
            </c:strRef>
          </c:cat>
          <c:val>
            <c:numRef>
              <c:f>Sheet1!$ALL$4:$ALL$7</c:f>
              <c:numCache>
                <c:formatCode>General</c:formatCode>
                <c:ptCount val="4"/>
                <c:pt idx="0" formatCode="0.00E+00">
                  <c:v>61045.571428571428</c:v>
                </c:pt>
                <c:pt idx="1">
                  <c:v>117414.75</c:v>
                </c:pt>
                <c:pt idx="2">
                  <c:v>168607.4</c:v>
                </c:pt>
                <c:pt idx="3">
                  <c:v>111660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A60-49A0-96E3-A5B94D7C08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3315888"/>
        <c:axId val="343315104"/>
      </c:barChart>
      <c:catAx>
        <c:axId val="3433158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43315104"/>
        <c:crosses val="autoZero"/>
        <c:auto val="1"/>
        <c:lblAlgn val="ctr"/>
        <c:lblOffset val="100"/>
        <c:noMultiLvlLbl val="0"/>
      </c:catAx>
      <c:valAx>
        <c:axId val="343315104"/>
        <c:scaling>
          <c:orientation val="minMax"/>
        </c:scaling>
        <c:delete val="0"/>
        <c:axPos val="l"/>
        <c:numFmt formatCode="0.00E+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433158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>
                <a:solidFill>
                  <a:schemeClr val="tx1"/>
                </a:solidFill>
              </a:rPr>
              <a:t>PA (36:6)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PI$9:$API$12</c:f>
                <c:numCache>
                  <c:formatCode>General</c:formatCode>
                  <c:ptCount val="4"/>
                  <c:pt idx="0">
                    <c:v>29520.022446436164</c:v>
                  </c:pt>
                  <c:pt idx="1">
                    <c:v>54537.329462641152</c:v>
                  </c:pt>
                  <c:pt idx="2">
                    <c:v>28139.839240834339</c:v>
                  </c:pt>
                  <c:pt idx="3">
                    <c:v>32892.040503744975</c:v>
                  </c:pt>
                </c:numCache>
              </c:numRef>
            </c:plus>
            <c:minus>
              <c:numRef>
                <c:f>Sheet1!$API$9:$API$12</c:f>
                <c:numCache>
                  <c:formatCode>General</c:formatCode>
                  <c:ptCount val="4"/>
                  <c:pt idx="0">
                    <c:v>29520.022446436164</c:v>
                  </c:pt>
                  <c:pt idx="1">
                    <c:v>54537.329462641152</c:v>
                  </c:pt>
                  <c:pt idx="2">
                    <c:v>28139.839240834339</c:v>
                  </c:pt>
                  <c:pt idx="3">
                    <c:v>32892.0405037449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4:$A$7</c:f>
              <c:strCache>
                <c:ptCount val="4"/>
                <c:pt idx="0">
                  <c:v>T89</c:v>
                </c:pt>
                <c:pt idx="1">
                  <c:v>Line 1</c:v>
                </c:pt>
                <c:pt idx="2">
                  <c:v>Line 2</c:v>
                </c:pt>
                <c:pt idx="3">
                  <c:v>Line 3</c:v>
                </c:pt>
              </c:strCache>
            </c:strRef>
          </c:cat>
          <c:val>
            <c:numRef>
              <c:f>Sheet1!$APH$4:$APH$7</c:f>
              <c:numCache>
                <c:formatCode>General</c:formatCode>
                <c:ptCount val="4"/>
                <c:pt idx="0" formatCode="0.00E+00">
                  <c:v>55282.428571428572</c:v>
                </c:pt>
                <c:pt idx="1">
                  <c:v>86662.75</c:v>
                </c:pt>
                <c:pt idx="2">
                  <c:v>109660.4</c:v>
                </c:pt>
                <c:pt idx="3">
                  <c:v>66017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BD5-4939-8CFE-C45DB2B1AA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3317064"/>
        <c:axId val="343313928"/>
      </c:barChart>
      <c:catAx>
        <c:axId val="343317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43313928"/>
        <c:crosses val="autoZero"/>
        <c:auto val="1"/>
        <c:lblAlgn val="ctr"/>
        <c:lblOffset val="100"/>
        <c:noMultiLvlLbl val="0"/>
      </c:catAx>
      <c:valAx>
        <c:axId val="343313928"/>
        <c:scaling>
          <c:orientation val="minMax"/>
        </c:scaling>
        <c:delete val="0"/>
        <c:axPos val="l"/>
        <c:numFmt formatCode="0.00E+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433170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>
                <a:solidFill>
                  <a:schemeClr val="tx1"/>
                </a:solidFill>
              </a:rPr>
              <a:t>DGDG (36:5)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LJ$9:$ALJ$12</c:f>
                <c:numCache>
                  <c:formatCode>General</c:formatCode>
                  <c:ptCount val="4"/>
                  <c:pt idx="0">
                    <c:v>4225.1887700855605</c:v>
                  </c:pt>
                  <c:pt idx="1">
                    <c:v>11290.895166755676</c:v>
                  </c:pt>
                  <c:pt idx="2">
                    <c:v>6887.5142685877572</c:v>
                  </c:pt>
                  <c:pt idx="3">
                    <c:v>11066.465461022322</c:v>
                  </c:pt>
                </c:numCache>
              </c:numRef>
            </c:plus>
            <c:minus>
              <c:numRef>
                <c:f>Sheet1!$ALJ$9:$ALJ$12</c:f>
                <c:numCache>
                  <c:formatCode>General</c:formatCode>
                  <c:ptCount val="4"/>
                  <c:pt idx="0">
                    <c:v>4225.1887700855605</c:v>
                  </c:pt>
                  <c:pt idx="1">
                    <c:v>11290.895166755676</c:v>
                  </c:pt>
                  <c:pt idx="2">
                    <c:v>6887.5142685877572</c:v>
                  </c:pt>
                  <c:pt idx="3">
                    <c:v>11066.4654610223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4:$A$7</c:f>
              <c:strCache>
                <c:ptCount val="4"/>
                <c:pt idx="0">
                  <c:v>T89</c:v>
                </c:pt>
                <c:pt idx="1">
                  <c:v>Line 1</c:v>
                </c:pt>
                <c:pt idx="2">
                  <c:v>Line 2</c:v>
                </c:pt>
                <c:pt idx="3">
                  <c:v>Line 3</c:v>
                </c:pt>
              </c:strCache>
            </c:strRef>
          </c:cat>
          <c:val>
            <c:numRef>
              <c:f>Sheet1!$ALJ$4:$ALJ$7</c:f>
              <c:numCache>
                <c:formatCode>General</c:formatCode>
                <c:ptCount val="4"/>
                <c:pt idx="0" formatCode="0.00E+00">
                  <c:v>10004.857142857143</c:v>
                </c:pt>
                <c:pt idx="1">
                  <c:v>23427.5</c:v>
                </c:pt>
                <c:pt idx="2">
                  <c:v>20770.599999999999</c:v>
                </c:pt>
                <c:pt idx="3">
                  <c:v>19314.5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5FC-44F5-9A67-B4E1A3A8DD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3312752"/>
        <c:axId val="343316280"/>
      </c:barChart>
      <c:catAx>
        <c:axId val="343312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43316280"/>
        <c:crosses val="autoZero"/>
        <c:auto val="1"/>
        <c:lblAlgn val="ctr"/>
        <c:lblOffset val="100"/>
        <c:noMultiLvlLbl val="0"/>
      </c:catAx>
      <c:valAx>
        <c:axId val="343316280"/>
        <c:scaling>
          <c:orientation val="minMax"/>
        </c:scaling>
        <c:delete val="0"/>
        <c:axPos val="l"/>
        <c:numFmt formatCode="0.00E+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433127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>
                <a:solidFill>
                  <a:schemeClr val="tx1"/>
                </a:solidFill>
              </a:rPr>
              <a:t>MGDG (36:2)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MD$9:$AMD$12</c:f>
                <c:numCache>
                  <c:formatCode>General</c:formatCode>
                  <c:ptCount val="4"/>
                  <c:pt idx="0">
                    <c:v>9096.5960823658825</c:v>
                  </c:pt>
                  <c:pt idx="1">
                    <c:v>21699.057220303373</c:v>
                  </c:pt>
                  <c:pt idx="2">
                    <c:v>14444.619458469655</c:v>
                  </c:pt>
                  <c:pt idx="3">
                    <c:v>21707.413588449454</c:v>
                  </c:pt>
                </c:numCache>
              </c:numRef>
            </c:plus>
            <c:minus>
              <c:numRef>
                <c:f>Sheet1!$AMD$9:$AMD$12</c:f>
                <c:numCache>
                  <c:formatCode>General</c:formatCode>
                  <c:ptCount val="4"/>
                  <c:pt idx="0">
                    <c:v>9096.5960823658825</c:v>
                  </c:pt>
                  <c:pt idx="1">
                    <c:v>21699.057220303373</c:v>
                  </c:pt>
                  <c:pt idx="2">
                    <c:v>14444.619458469655</c:v>
                  </c:pt>
                  <c:pt idx="3">
                    <c:v>21707.4135884494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4:$A$7</c:f>
              <c:strCache>
                <c:ptCount val="4"/>
                <c:pt idx="0">
                  <c:v>T89</c:v>
                </c:pt>
                <c:pt idx="1">
                  <c:v>Line 1</c:v>
                </c:pt>
                <c:pt idx="2">
                  <c:v>Line 2</c:v>
                </c:pt>
                <c:pt idx="3">
                  <c:v>Line 3</c:v>
                </c:pt>
              </c:strCache>
            </c:strRef>
          </c:cat>
          <c:val>
            <c:numRef>
              <c:f>Sheet1!$AMD$4:$AMD$7</c:f>
              <c:numCache>
                <c:formatCode>General</c:formatCode>
                <c:ptCount val="4"/>
                <c:pt idx="0" formatCode="0.00E+00">
                  <c:v>17670.428571428572</c:v>
                </c:pt>
                <c:pt idx="1">
                  <c:v>37244.75</c:v>
                </c:pt>
                <c:pt idx="2">
                  <c:v>43838.6</c:v>
                </c:pt>
                <c:pt idx="3">
                  <c:v>32457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D28-49CF-9076-E34E916DAA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3312360"/>
        <c:axId val="343316672"/>
      </c:barChart>
      <c:catAx>
        <c:axId val="343312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43316672"/>
        <c:crosses val="autoZero"/>
        <c:auto val="1"/>
        <c:lblAlgn val="ctr"/>
        <c:lblOffset val="100"/>
        <c:noMultiLvlLbl val="0"/>
      </c:catAx>
      <c:valAx>
        <c:axId val="343316672"/>
        <c:scaling>
          <c:orientation val="minMax"/>
        </c:scaling>
        <c:delete val="0"/>
        <c:axPos val="l"/>
        <c:numFmt formatCode="0.00E+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433123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>
                <a:solidFill>
                  <a:schemeClr val="tx1"/>
                </a:solidFill>
              </a:rPr>
              <a:t>PA (36:5)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PL$9:$APL$12</c:f>
                <c:numCache>
                  <c:formatCode>General</c:formatCode>
                  <c:ptCount val="4"/>
                  <c:pt idx="0">
                    <c:v>67218.833447182042</c:v>
                  </c:pt>
                  <c:pt idx="1">
                    <c:v>101454.47258540815</c:v>
                  </c:pt>
                  <c:pt idx="2">
                    <c:v>73141.659007025562</c:v>
                  </c:pt>
                  <c:pt idx="3">
                    <c:v>90953.654669287469</c:v>
                  </c:pt>
                </c:numCache>
              </c:numRef>
            </c:plus>
            <c:minus>
              <c:numRef>
                <c:f>Sheet1!$APL$9:$APL$12</c:f>
                <c:numCache>
                  <c:formatCode>General</c:formatCode>
                  <c:ptCount val="4"/>
                  <c:pt idx="0">
                    <c:v>67218.833447182042</c:v>
                  </c:pt>
                  <c:pt idx="1">
                    <c:v>101454.47258540815</c:v>
                  </c:pt>
                  <c:pt idx="2">
                    <c:v>73141.659007025562</c:v>
                  </c:pt>
                  <c:pt idx="3">
                    <c:v>90953.6546692874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4:$A$7</c:f>
              <c:strCache>
                <c:ptCount val="4"/>
                <c:pt idx="0">
                  <c:v>T89</c:v>
                </c:pt>
                <c:pt idx="1">
                  <c:v>Line 1</c:v>
                </c:pt>
                <c:pt idx="2">
                  <c:v>Line 2</c:v>
                </c:pt>
                <c:pt idx="3">
                  <c:v>Line 3</c:v>
                </c:pt>
              </c:strCache>
            </c:strRef>
          </c:cat>
          <c:val>
            <c:numRef>
              <c:f>Sheet1!$APK$4:$APK$7</c:f>
              <c:numCache>
                <c:formatCode>General</c:formatCode>
                <c:ptCount val="4"/>
                <c:pt idx="0" formatCode="0.00E+00">
                  <c:v>177942.14285714287</c:v>
                </c:pt>
                <c:pt idx="1">
                  <c:v>253148.5</c:v>
                </c:pt>
                <c:pt idx="2">
                  <c:v>335743.8</c:v>
                </c:pt>
                <c:pt idx="3">
                  <c:v>211056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71-4F3A-9C87-CA2DBCE0D5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3314712"/>
        <c:axId val="343317456"/>
      </c:barChart>
      <c:catAx>
        <c:axId val="343314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43317456"/>
        <c:crosses val="autoZero"/>
        <c:auto val="1"/>
        <c:lblAlgn val="ctr"/>
        <c:lblOffset val="100"/>
        <c:noMultiLvlLbl val="0"/>
      </c:catAx>
      <c:valAx>
        <c:axId val="343317456"/>
        <c:scaling>
          <c:orientation val="minMax"/>
        </c:scaling>
        <c:delete val="0"/>
        <c:axPos val="l"/>
        <c:numFmt formatCode="0.00E+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433147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8F8572-90B9-468F-BC9F-F559F8A54D4D}" type="datetimeFigureOut">
              <a:rPr lang="sv-SE" smtClean="0"/>
              <a:t>2017-11-30</a:t>
            </a:fld>
            <a:endParaRPr lang="sv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9475" y="1235075"/>
            <a:ext cx="2498725" cy="33321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51388"/>
            <a:ext cx="5438775" cy="38893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950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378950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2EA21C-1D5E-482D-8A84-CBF0FF3FBBD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168131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C87A-2670-40F7-89DA-B594120D2684}" type="datetimeFigureOut">
              <a:rPr lang="sv-SE" smtClean="0"/>
              <a:t>2017-11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46D58F-9967-4080-A677-9D4ACB99D0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41598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C87A-2670-40F7-89DA-B594120D2684}" type="datetimeFigureOut">
              <a:rPr lang="sv-SE" smtClean="0"/>
              <a:t>2017-11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46D58F-9967-4080-A677-9D4ACB99D0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43239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C87A-2670-40F7-89DA-B594120D2684}" type="datetimeFigureOut">
              <a:rPr lang="sv-SE" smtClean="0"/>
              <a:t>2017-11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46D58F-9967-4080-A677-9D4ACB99D0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81814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C87A-2670-40F7-89DA-B594120D2684}" type="datetimeFigureOut">
              <a:rPr lang="sv-SE" smtClean="0"/>
              <a:t>2017-11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46D58F-9967-4080-A677-9D4ACB99D0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310764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C87A-2670-40F7-89DA-B594120D2684}" type="datetimeFigureOut">
              <a:rPr lang="sv-SE" smtClean="0"/>
              <a:t>2017-11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46D58F-9967-4080-A677-9D4ACB99D0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719756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C87A-2670-40F7-89DA-B594120D2684}" type="datetimeFigureOut">
              <a:rPr lang="sv-SE" smtClean="0"/>
              <a:t>2017-11-3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46D58F-9967-4080-A677-9D4ACB99D0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176641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C87A-2670-40F7-89DA-B594120D2684}" type="datetimeFigureOut">
              <a:rPr lang="sv-SE" smtClean="0"/>
              <a:t>2017-11-30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46D58F-9967-4080-A677-9D4ACB99D0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5305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C87A-2670-40F7-89DA-B594120D2684}" type="datetimeFigureOut">
              <a:rPr lang="sv-SE" smtClean="0"/>
              <a:t>2017-11-30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46D58F-9967-4080-A677-9D4ACB99D0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53892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C87A-2670-40F7-89DA-B594120D2684}" type="datetimeFigureOut">
              <a:rPr lang="sv-SE" smtClean="0"/>
              <a:t>2017-11-30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46D58F-9967-4080-A677-9D4ACB99D0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141392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C87A-2670-40F7-89DA-B594120D2684}" type="datetimeFigureOut">
              <a:rPr lang="sv-SE" smtClean="0"/>
              <a:t>2017-11-3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46D58F-9967-4080-A677-9D4ACB99D0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496953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C87A-2670-40F7-89DA-B594120D2684}" type="datetimeFigureOut">
              <a:rPr lang="sv-SE" smtClean="0"/>
              <a:t>2017-11-3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46D58F-9967-4080-A677-9D4ACB99D0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68367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2C87A-2670-40F7-89DA-B594120D2684}" type="datetimeFigureOut">
              <a:rPr lang="sv-SE" smtClean="0"/>
              <a:t>2017-11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46D58F-9967-4080-A677-9D4ACB99D05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63262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1779529"/>
              </p:ext>
            </p:extLst>
          </p:nvPr>
        </p:nvGraphicFramePr>
        <p:xfrm>
          <a:off x="392307" y="1200150"/>
          <a:ext cx="2905627" cy="21145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2311440"/>
              </p:ext>
            </p:extLst>
          </p:nvPr>
        </p:nvGraphicFramePr>
        <p:xfrm>
          <a:off x="3519488" y="1204417"/>
          <a:ext cx="2941833" cy="20874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5989060"/>
              </p:ext>
            </p:extLst>
          </p:nvPr>
        </p:nvGraphicFramePr>
        <p:xfrm>
          <a:off x="346943" y="3419871"/>
          <a:ext cx="2920132" cy="18474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79191884"/>
              </p:ext>
            </p:extLst>
          </p:nvPr>
        </p:nvGraphicFramePr>
        <p:xfrm>
          <a:off x="3524250" y="3419476"/>
          <a:ext cx="2929086" cy="18287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3153245"/>
              </p:ext>
            </p:extLst>
          </p:nvPr>
        </p:nvGraphicFramePr>
        <p:xfrm>
          <a:off x="332656" y="5796137"/>
          <a:ext cx="2943225" cy="18333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6660869"/>
              </p:ext>
            </p:extLst>
          </p:nvPr>
        </p:nvGraphicFramePr>
        <p:xfrm>
          <a:off x="3477927" y="5796136"/>
          <a:ext cx="2952328" cy="18554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40" name="TextBox 39"/>
          <p:cNvSpPr txBox="1"/>
          <p:nvPr/>
        </p:nvSpPr>
        <p:spPr>
          <a:xfrm>
            <a:off x="332656" y="292170"/>
            <a:ext cx="17283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dditional file 8</a:t>
            </a:r>
            <a:endParaRPr lang="sv-SE" dirty="0"/>
          </a:p>
        </p:txBody>
      </p:sp>
      <p:sp>
        <p:nvSpPr>
          <p:cNvPr id="10" name="Rectangle 27">
            <a:extLst>
              <a:ext uri="{FF2B5EF4-FFF2-40B4-BE49-F238E27FC236}">
                <a16:creationId xmlns:a16="http://schemas.microsoft.com/office/drawing/2014/main" id="{70D59623-C9F6-4334-997D-EA753C1359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15341" y="3083990"/>
            <a:ext cx="202361" cy="1384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WT</a:t>
            </a:r>
            <a:endParaRPr kumimoji="0" lang="sv-SE" altLang="sv-SE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" name="Rectangle 27">
            <a:extLst>
              <a:ext uri="{FF2B5EF4-FFF2-40B4-BE49-F238E27FC236}">
                <a16:creationId xmlns:a16="http://schemas.microsoft.com/office/drawing/2014/main" id="{4557E193-8D87-4F15-8C52-EFD1656E5F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6752" y="3093909"/>
            <a:ext cx="202361" cy="1384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WT</a:t>
            </a:r>
            <a:endParaRPr kumimoji="0" lang="sv-SE" altLang="sv-SE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Rectangle 27">
            <a:extLst>
              <a:ext uri="{FF2B5EF4-FFF2-40B4-BE49-F238E27FC236}">
                <a16:creationId xmlns:a16="http://schemas.microsoft.com/office/drawing/2014/main" id="{3533218A-440A-4D4B-BBCD-8D1943C5D0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24469" y="5025118"/>
            <a:ext cx="202361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WT</a:t>
            </a:r>
            <a:endParaRPr kumimoji="0" lang="sv-SE" altLang="sv-SE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" name="Rectangle 27">
            <a:extLst>
              <a:ext uri="{FF2B5EF4-FFF2-40B4-BE49-F238E27FC236}">
                <a16:creationId xmlns:a16="http://schemas.microsoft.com/office/drawing/2014/main" id="{0E9D9B82-E798-4F93-8424-734F7095B5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39822" y="5046529"/>
            <a:ext cx="202361" cy="1384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WT</a:t>
            </a:r>
            <a:endParaRPr kumimoji="0" lang="sv-SE" altLang="sv-SE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" name="Rectangle 27">
            <a:extLst>
              <a:ext uri="{FF2B5EF4-FFF2-40B4-BE49-F238E27FC236}">
                <a16:creationId xmlns:a16="http://schemas.microsoft.com/office/drawing/2014/main" id="{ADED4CC4-73EF-4152-8F8C-A9BFDB4AFE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19336" y="7390251"/>
            <a:ext cx="202361" cy="1384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WT</a:t>
            </a:r>
            <a:endParaRPr kumimoji="0" lang="sv-SE" altLang="sv-SE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" name="Rectangle 27">
            <a:extLst>
              <a:ext uri="{FF2B5EF4-FFF2-40B4-BE49-F238E27FC236}">
                <a16:creationId xmlns:a16="http://schemas.microsoft.com/office/drawing/2014/main" id="{D057605A-7D49-4D24-B068-67D0D7C652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76193" y="7424464"/>
            <a:ext cx="202361" cy="1384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altLang="sv-SE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WT</a:t>
            </a:r>
            <a:endParaRPr kumimoji="0" lang="sv-SE" altLang="sv-SE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27799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17</TotalTime>
  <Words>39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PS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a Milhinhos</dc:creator>
  <cp:lastModifiedBy>Hannele Tuominen</cp:lastModifiedBy>
  <cp:revision>63</cp:revision>
  <cp:lastPrinted>2017-05-26T13:06:44Z</cp:lastPrinted>
  <dcterms:created xsi:type="dcterms:W3CDTF">2015-09-30T09:28:25Z</dcterms:created>
  <dcterms:modified xsi:type="dcterms:W3CDTF">2017-11-30T13:23:36Z</dcterms:modified>
</cp:coreProperties>
</file>